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83076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9935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72351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63049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09020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58110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46051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73608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06946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71258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22413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7FECC-5709-4F23-B6D8-444ACE44E90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FD1D0-18AA-4621-8CC8-8D548BEAD96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6451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close up of a map&#10;&#10;Description generated with high confidence">
            <a:extLst>
              <a:ext uri="{FF2B5EF4-FFF2-40B4-BE49-F238E27FC236}">
                <a16:creationId xmlns:a16="http://schemas.microsoft.com/office/drawing/2014/main" id="{A4E93720-978C-4C97-AAED-92CB26CB58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3305" y="1259083"/>
            <a:ext cx="8763849" cy="42504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9141D2D-936A-4D42-9D2F-A02C8802E6F3}"/>
              </a:ext>
            </a:extLst>
          </p:cNvPr>
          <p:cNvSpPr txBox="1"/>
          <p:nvPr/>
        </p:nvSpPr>
        <p:spPr>
          <a:xfrm>
            <a:off x="4610032" y="1919468"/>
            <a:ext cx="10486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Solvent Blank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9341596-4487-4E88-8981-4E4D2C6161BF}"/>
              </a:ext>
            </a:extLst>
          </p:cNvPr>
          <p:cNvSpPr txBox="1"/>
          <p:nvPr/>
        </p:nvSpPr>
        <p:spPr>
          <a:xfrm>
            <a:off x="4698358" y="4254661"/>
            <a:ext cx="19207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FD734F-A241-453A-A261-EAD11C60F650}"/>
              </a:ext>
            </a:extLst>
          </p:cNvPr>
          <p:cNvSpPr txBox="1"/>
          <p:nvPr/>
        </p:nvSpPr>
        <p:spPr>
          <a:xfrm>
            <a:off x="1240286" y="5711422"/>
            <a:ext cx="423705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Negative mode BPI chromatogram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</p:spTree>
    <p:extLst>
      <p:ext uri="{BB962C8B-B14F-4D97-AF65-F5344CB8AC3E}">
        <p14:creationId xmlns:p14="http://schemas.microsoft.com/office/powerpoint/2010/main" val="2337442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3</cp:revision>
  <dcterms:created xsi:type="dcterms:W3CDTF">2017-04-27T07:49:50Z</dcterms:created>
  <dcterms:modified xsi:type="dcterms:W3CDTF">2017-09-21T09:23:55Z</dcterms:modified>
</cp:coreProperties>
</file>